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7" r:id="rId2"/>
    <p:sldId id="268" r:id="rId3"/>
  </p:sldIdLst>
  <p:sldSz cx="6048375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19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70"/>
    <p:restoredTop sz="94866"/>
  </p:normalViewPr>
  <p:slideViewPr>
    <p:cSldViewPr snapToGrid="0" snapToObjects="1">
      <p:cViewPr>
        <p:scale>
          <a:sx n="116" d="100"/>
          <a:sy n="116" d="100"/>
        </p:scale>
        <p:origin x="-2816" y="-488"/>
      </p:cViewPr>
      <p:guideLst>
        <p:guide orient="horz" pos="2160"/>
        <p:guide pos="19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3630" y="1122363"/>
            <a:ext cx="5141118" cy="2387600"/>
          </a:xfrm>
        </p:spPr>
        <p:txBody>
          <a:bodyPr anchor="b"/>
          <a:lstStyle>
            <a:lvl1pPr algn="ctr">
              <a:defRPr sz="39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56048" y="3602038"/>
            <a:ext cx="4536282" cy="1655762"/>
          </a:xfrm>
        </p:spPr>
        <p:txBody>
          <a:bodyPr/>
          <a:lstStyle>
            <a:lvl1pPr marL="0" indent="0" algn="ctr">
              <a:buNone/>
              <a:defRPr sz="1588"/>
            </a:lvl1pPr>
            <a:lvl2pPr marL="302424" indent="0" algn="ctr">
              <a:buNone/>
              <a:defRPr sz="1323"/>
            </a:lvl2pPr>
            <a:lvl3pPr marL="604846" indent="0" algn="ctr">
              <a:buNone/>
              <a:defRPr sz="1191"/>
            </a:lvl3pPr>
            <a:lvl4pPr marL="907271" indent="0" algn="ctr">
              <a:buNone/>
              <a:defRPr sz="1059"/>
            </a:lvl4pPr>
            <a:lvl5pPr marL="1209693" indent="0" algn="ctr">
              <a:buNone/>
              <a:defRPr sz="1059"/>
            </a:lvl5pPr>
            <a:lvl6pPr marL="1512117" indent="0" algn="ctr">
              <a:buNone/>
              <a:defRPr sz="1059"/>
            </a:lvl6pPr>
            <a:lvl7pPr marL="1814542" indent="0" algn="ctr">
              <a:buNone/>
              <a:defRPr sz="1059"/>
            </a:lvl7pPr>
            <a:lvl8pPr marL="2116966" indent="0" algn="ctr">
              <a:buNone/>
              <a:defRPr sz="1059"/>
            </a:lvl8pPr>
            <a:lvl9pPr marL="2419388" indent="0" algn="ctr">
              <a:buNone/>
              <a:defRPr sz="1059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4597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1163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28373" y="365125"/>
            <a:ext cx="13041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15826" y="365125"/>
            <a:ext cx="383693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309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299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2676" y="1709744"/>
            <a:ext cx="5216724" cy="2852737"/>
          </a:xfrm>
        </p:spPr>
        <p:txBody>
          <a:bodyPr anchor="b"/>
          <a:lstStyle>
            <a:lvl1pPr>
              <a:defRPr sz="39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2676" y="4589469"/>
            <a:ext cx="5216724" cy="1500187"/>
          </a:xfrm>
        </p:spPr>
        <p:txBody>
          <a:bodyPr/>
          <a:lstStyle>
            <a:lvl1pPr marL="0" indent="0">
              <a:buNone/>
              <a:defRPr sz="1588">
                <a:solidFill>
                  <a:schemeClr val="tx1"/>
                </a:solidFill>
              </a:defRPr>
            </a:lvl1pPr>
            <a:lvl2pPr marL="30242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2pPr>
            <a:lvl3pPr marL="604846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3pPr>
            <a:lvl4pPr marL="907271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4pPr>
            <a:lvl5pPr marL="1209693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5pPr>
            <a:lvl6pPr marL="1512117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6pPr>
            <a:lvl7pPr marL="1814542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7pPr>
            <a:lvl8pPr marL="2116966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8pPr>
            <a:lvl9pPr marL="2419388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0273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5829" y="1825625"/>
            <a:ext cx="257055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1994" y="1825625"/>
            <a:ext cx="257055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6459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4" y="365129"/>
            <a:ext cx="5216724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6616" y="1681163"/>
            <a:ext cx="2558747" cy="823912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24" indent="0">
              <a:buNone/>
              <a:defRPr sz="1323" b="1"/>
            </a:lvl2pPr>
            <a:lvl3pPr marL="604846" indent="0">
              <a:buNone/>
              <a:defRPr sz="1191" b="1"/>
            </a:lvl3pPr>
            <a:lvl4pPr marL="907271" indent="0">
              <a:buNone/>
              <a:defRPr sz="1059" b="1"/>
            </a:lvl4pPr>
            <a:lvl5pPr marL="1209693" indent="0">
              <a:buNone/>
              <a:defRPr sz="1059" b="1"/>
            </a:lvl5pPr>
            <a:lvl6pPr marL="1512117" indent="0">
              <a:buNone/>
              <a:defRPr sz="1059" b="1"/>
            </a:lvl6pPr>
            <a:lvl7pPr marL="1814542" indent="0">
              <a:buNone/>
              <a:defRPr sz="1059" b="1"/>
            </a:lvl7pPr>
            <a:lvl8pPr marL="2116966" indent="0">
              <a:buNone/>
              <a:defRPr sz="1059" b="1"/>
            </a:lvl8pPr>
            <a:lvl9pPr marL="2419388" indent="0">
              <a:buNone/>
              <a:defRPr sz="1059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16" y="2505075"/>
            <a:ext cx="255874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61990" y="1681163"/>
            <a:ext cx="2571347" cy="823912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24" indent="0">
              <a:buNone/>
              <a:defRPr sz="1323" b="1"/>
            </a:lvl2pPr>
            <a:lvl3pPr marL="604846" indent="0">
              <a:buNone/>
              <a:defRPr sz="1191" b="1"/>
            </a:lvl3pPr>
            <a:lvl4pPr marL="907271" indent="0">
              <a:buNone/>
              <a:defRPr sz="1059" b="1"/>
            </a:lvl4pPr>
            <a:lvl5pPr marL="1209693" indent="0">
              <a:buNone/>
              <a:defRPr sz="1059" b="1"/>
            </a:lvl5pPr>
            <a:lvl6pPr marL="1512117" indent="0">
              <a:buNone/>
              <a:defRPr sz="1059" b="1"/>
            </a:lvl6pPr>
            <a:lvl7pPr marL="1814542" indent="0">
              <a:buNone/>
              <a:defRPr sz="1059" b="1"/>
            </a:lvl7pPr>
            <a:lvl8pPr marL="2116966" indent="0">
              <a:buNone/>
              <a:defRPr sz="1059" b="1"/>
            </a:lvl8pPr>
            <a:lvl9pPr marL="2419388" indent="0">
              <a:buNone/>
              <a:defRPr sz="1059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61990" y="2505075"/>
            <a:ext cx="257134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908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001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218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3" y="457200"/>
            <a:ext cx="1950758" cy="1600200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1350" y="987431"/>
            <a:ext cx="3061990" cy="4873625"/>
          </a:xfrm>
        </p:spPr>
        <p:txBody>
          <a:bodyPr/>
          <a:lstStyle>
            <a:lvl1pPr>
              <a:defRPr sz="2117"/>
            </a:lvl1pPr>
            <a:lvl2pPr>
              <a:defRPr sz="1852"/>
            </a:lvl2pPr>
            <a:lvl3pPr>
              <a:defRPr sz="1588"/>
            </a:lvl3pPr>
            <a:lvl4pPr>
              <a:defRPr sz="1323"/>
            </a:lvl4pPr>
            <a:lvl5pPr>
              <a:defRPr sz="1323"/>
            </a:lvl5pPr>
            <a:lvl6pPr>
              <a:defRPr sz="1323"/>
            </a:lvl6pPr>
            <a:lvl7pPr>
              <a:defRPr sz="1323"/>
            </a:lvl7pPr>
            <a:lvl8pPr>
              <a:defRPr sz="1323"/>
            </a:lvl8pPr>
            <a:lvl9pPr>
              <a:defRPr sz="132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3" y="2057400"/>
            <a:ext cx="1950758" cy="3811588"/>
          </a:xfrm>
        </p:spPr>
        <p:txBody>
          <a:bodyPr/>
          <a:lstStyle>
            <a:lvl1pPr marL="0" indent="0">
              <a:buNone/>
              <a:defRPr sz="1059"/>
            </a:lvl1pPr>
            <a:lvl2pPr marL="302424" indent="0">
              <a:buNone/>
              <a:defRPr sz="926"/>
            </a:lvl2pPr>
            <a:lvl3pPr marL="604846" indent="0">
              <a:buNone/>
              <a:defRPr sz="794"/>
            </a:lvl3pPr>
            <a:lvl4pPr marL="907271" indent="0">
              <a:buNone/>
              <a:defRPr sz="662"/>
            </a:lvl4pPr>
            <a:lvl5pPr marL="1209693" indent="0">
              <a:buNone/>
              <a:defRPr sz="662"/>
            </a:lvl5pPr>
            <a:lvl6pPr marL="1512117" indent="0">
              <a:buNone/>
              <a:defRPr sz="662"/>
            </a:lvl6pPr>
            <a:lvl7pPr marL="1814542" indent="0">
              <a:buNone/>
              <a:defRPr sz="662"/>
            </a:lvl7pPr>
            <a:lvl8pPr marL="2116966" indent="0">
              <a:buNone/>
              <a:defRPr sz="662"/>
            </a:lvl8pPr>
            <a:lvl9pPr marL="2419388" indent="0">
              <a:buNone/>
              <a:defRPr sz="66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9097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3" y="457200"/>
            <a:ext cx="1950758" cy="1600200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71350" y="987431"/>
            <a:ext cx="3061990" cy="4873625"/>
          </a:xfrm>
        </p:spPr>
        <p:txBody>
          <a:bodyPr anchor="t"/>
          <a:lstStyle>
            <a:lvl1pPr marL="0" indent="0">
              <a:buNone/>
              <a:defRPr sz="2117"/>
            </a:lvl1pPr>
            <a:lvl2pPr marL="302424" indent="0">
              <a:buNone/>
              <a:defRPr sz="1852"/>
            </a:lvl2pPr>
            <a:lvl3pPr marL="604846" indent="0">
              <a:buNone/>
              <a:defRPr sz="1588"/>
            </a:lvl3pPr>
            <a:lvl4pPr marL="907271" indent="0">
              <a:buNone/>
              <a:defRPr sz="1323"/>
            </a:lvl4pPr>
            <a:lvl5pPr marL="1209693" indent="0">
              <a:buNone/>
              <a:defRPr sz="1323"/>
            </a:lvl5pPr>
            <a:lvl6pPr marL="1512117" indent="0">
              <a:buNone/>
              <a:defRPr sz="1323"/>
            </a:lvl6pPr>
            <a:lvl7pPr marL="1814542" indent="0">
              <a:buNone/>
              <a:defRPr sz="1323"/>
            </a:lvl7pPr>
            <a:lvl8pPr marL="2116966" indent="0">
              <a:buNone/>
              <a:defRPr sz="1323"/>
            </a:lvl8pPr>
            <a:lvl9pPr marL="2419388" indent="0">
              <a:buNone/>
              <a:defRPr sz="1323"/>
            </a:lvl9pPr>
          </a:lstStyle>
          <a:p>
            <a:r>
              <a:rPr lang="de-DE"/>
              <a:t>Bild auf Platzhalter ziehen oder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3" y="2057400"/>
            <a:ext cx="1950758" cy="3811588"/>
          </a:xfrm>
        </p:spPr>
        <p:txBody>
          <a:bodyPr/>
          <a:lstStyle>
            <a:lvl1pPr marL="0" indent="0">
              <a:buNone/>
              <a:defRPr sz="1059"/>
            </a:lvl1pPr>
            <a:lvl2pPr marL="302424" indent="0">
              <a:buNone/>
              <a:defRPr sz="926"/>
            </a:lvl2pPr>
            <a:lvl3pPr marL="604846" indent="0">
              <a:buNone/>
              <a:defRPr sz="794"/>
            </a:lvl3pPr>
            <a:lvl4pPr marL="907271" indent="0">
              <a:buNone/>
              <a:defRPr sz="662"/>
            </a:lvl4pPr>
            <a:lvl5pPr marL="1209693" indent="0">
              <a:buNone/>
              <a:defRPr sz="662"/>
            </a:lvl5pPr>
            <a:lvl6pPr marL="1512117" indent="0">
              <a:buNone/>
              <a:defRPr sz="662"/>
            </a:lvl6pPr>
            <a:lvl7pPr marL="1814542" indent="0">
              <a:buNone/>
              <a:defRPr sz="662"/>
            </a:lvl7pPr>
            <a:lvl8pPr marL="2116966" indent="0">
              <a:buNone/>
              <a:defRPr sz="662"/>
            </a:lvl8pPr>
            <a:lvl9pPr marL="2419388" indent="0">
              <a:buNone/>
              <a:defRPr sz="66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4930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5829" y="365129"/>
            <a:ext cx="521672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5829" y="1825625"/>
            <a:ext cx="521672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5826" y="6356356"/>
            <a:ext cx="13608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03528" y="6356356"/>
            <a:ext cx="204132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71665" y="6356356"/>
            <a:ext cx="13608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0426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4846" rtl="0" eaLnBrk="1" latinLnBrk="0" hangingPunct="1">
        <a:lnSpc>
          <a:spcPct val="90000"/>
        </a:lnSpc>
        <a:spcBef>
          <a:spcPct val="0"/>
        </a:spcBef>
        <a:buNone/>
        <a:defRPr sz="29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1211" indent="-151211" algn="l" defTabSz="604846" rtl="0" eaLnBrk="1" latinLnBrk="0" hangingPunct="1">
        <a:lnSpc>
          <a:spcPct val="90000"/>
        </a:lnSpc>
        <a:spcBef>
          <a:spcPts val="662"/>
        </a:spcBef>
        <a:buFont typeface="Arial" panose="020B0604020202020204" pitchFamily="34" charset="0"/>
        <a:buChar char="•"/>
        <a:defRPr sz="1852" kern="1200">
          <a:solidFill>
            <a:schemeClr val="tx1"/>
          </a:solidFill>
          <a:latin typeface="+mn-lt"/>
          <a:ea typeface="+mn-ea"/>
          <a:cs typeface="+mn-cs"/>
        </a:defRPr>
      </a:lvl1pPr>
      <a:lvl2pPr marL="453635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588" kern="1200">
          <a:solidFill>
            <a:schemeClr val="tx1"/>
          </a:solidFill>
          <a:latin typeface="+mn-lt"/>
          <a:ea typeface="+mn-ea"/>
          <a:cs typeface="+mn-cs"/>
        </a:defRPr>
      </a:lvl2pPr>
      <a:lvl3pPr marL="756060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58482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360906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663330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965753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268177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570599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1pPr>
      <a:lvl2pPr marL="302424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2pPr>
      <a:lvl3pPr marL="604846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3pPr>
      <a:lvl4pPr marL="907271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209693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512117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814542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116966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419388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feld 27"/>
          <p:cNvSpPr txBox="1"/>
          <p:nvPr/>
        </p:nvSpPr>
        <p:spPr>
          <a:xfrm>
            <a:off x="252688" y="140802"/>
            <a:ext cx="57956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Helvetica"/>
                <a:ea typeface="Times New Roman" charset="0"/>
                <a:cs typeface="Helvetica"/>
              </a:rPr>
              <a:t>Table S1</a:t>
            </a:r>
            <a:r>
              <a:rPr lang="en-US" sz="800" b="1" dirty="0">
                <a:latin typeface="Helvetica"/>
                <a:ea typeface="Times New Roman" charset="0"/>
                <a:cs typeface="Helvetica"/>
              </a:rPr>
              <a:t>. Reporter gene expression of 27 EMS mutant lines. </a:t>
            </a:r>
            <a:r>
              <a:rPr lang="en-US" sz="800" dirty="0">
                <a:latin typeface="Helvetica"/>
                <a:ea typeface="Times New Roman" charset="0"/>
                <a:cs typeface="Helvetica"/>
              </a:rPr>
              <a:t>+, more signal; -, less signal. </a:t>
            </a:r>
          </a:p>
        </p:txBody>
      </p:sp>
      <p:graphicFrame>
        <p:nvGraphicFramePr>
          <p:cNvPr id="29" name="Tabel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2537147"/>
              </p:ext>
            </p:extLst>
          </p:nvPr>
        </p:nvGraphicFramePr>
        <p:xfrm>
          <a:off x="405107" y="555990"/>
          <a:ext cx="1668480" cy="5443069"/>
        </p:xfrm>
        <a:graphic>
          <a:graphicData uri="http://schemas.openxmlformats.org/drawingml/2006/table">
            <a:tbl>
              <a:tblPr/>
              <a:tblGrid>
                <a:gridCol w="79732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711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315823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Mutant Nr.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LUC/GFP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signal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73980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L02</a:t>
                      </a: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Helvetica"/>
                          <a:ea typeface="Calibri" charset="0"/>
                          <a:cs typeface="Helvetica"/>
                        </a:rPr>
                        <a:t>+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2870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Helvetica"/>
                          <a:ea typeface="Calibri" charset="0"/>
                          <a:cs typeface="Helvetica"/>
                        </a:rPr>
                        <a:t>L03</a:t>
                      </a: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Helvetica"/>
                          <a:ea typeface="Calibri" charset="0"/>
                          <a:cs typeface="Helvetica"/>
                        </a:rPr>
                        <a:t>+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35912671"/>
                  </a:ext>
                </a:extLst>
              </a:tr>
              <a:tr h="173980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Helvetica"/>
                          <a:ea typeface="Calibri" charset="0"/>
                          <a:cs typeface="Helvetica"/>
                        </a:rPr>
                        <a:t>G01</a:t>
                      </a: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Helvetica"/>
                          <a:ea typeface="Calibri" charset="0"/>
                          <a:cs typeface="Helvetica"/>
                        </a:rPr>
                        <a:t>+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56965348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2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3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4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5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6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7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8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i-FI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09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0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1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2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3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4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5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6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</a:t>
                      </a:r>
                      <a:r>
                        <a:rPr lang="de-DE" sz="800" kern="1200" baseline="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 wider </a:t>
                      </a:r>
                      <a:r>
                        <a:rPr lang="de-DE" sz="800" kern="1200" baseline="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7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</a:t>
                      </a:r>
                      <a:r>
                        <a:rPr lang="de-DE" sz="800" kern="1200" baseline="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 </a:t>
                      </a:r>
                      <a:r>
                        <a:rPr lang="de-DE" sz="800" kern="1200" baseline="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8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cs-CZ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19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0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+; wider </a:t>
                      </a:r>
                      <a:r>
                        <a:rPr lang="de-DE" sz="800" kern="1200" dirty="0" err="1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bundle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s-IS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1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-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2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-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3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-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4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Diffused</a:t>
                      </a:r>
                      <a:r>
                        <a:rPr lang="de-DE" sz="800" kern="12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 signal 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6142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cs-CZ" sz="800" kern="12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G25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800" kern="1200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Diffused</a:t>
                      </a:r>
                      <a:r>
                        <a:rPr lang="de-DE" sz="800" kern="12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Times New Roman" charset="0"/>
                          <a:cs typeface="Helvetica"/>
                        </a:rPr>
                        <a:t> signal</a:t>
                      </a:r>
                      <a:endParaRPr lang="de-DE" sz="800" dirty="0">
                        <a:effectLst/>
                        <a:latin typeface="Helvetica"/>
                        <a:ea typeface="Calibri" charset="0"/>
                        <a:cs typeface="Helvetica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8655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52688" y="401727"/>
            <a:ext cx="5653087" cy="2710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b="1" u="sng" dirty="0">
                <a:latin typeface="Helvetica"/>
                <a:ea typeface="Calibri" charset="0"/>
                <a:cs typeface="Helvetica"/>
              </a:rPr>
              <a:t>Primer		Sequence (5’</a:t>
            </a:r>
            <a:r>
              <a:rPr lang="en-US" sz="800" b="1" u="sng" dirty="0">
                <a:latin typeface="Helvetica"/>
                <a:ea typeface="Calibri" charset="0"/>
                <a:cs typeface="Helvetica"/>
                <a:sym typeface="Wingdings" charset="2"/>
              </a:rPr>
              <a:t></a:t>
            </a:r>
            <a:r>
              <a:rPr lang="en-US" sz="800" b="1" u="sng" dirty="0">
                <a:latin typeface="Helvetica"/>
                <a:ea typeface="Calibri" charset="0"/>
                <a:cs typeface="Helvetica"/>
              </a:rPr>
              <a:t> 3’)			Orientation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-Ft-F		TACTCCTCTCAACTTTCAA	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-Ft-R		AGTGTAAGATGGGGTCTAA		R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>
                <a:latin typeface="Helvetica"/>
                <a:ea typeface="Calibri" charset="0"/>
                <a:cs typeface="Helvetica"/>
              </a:rPr>
              <a:t>Att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B1	</a:t>
            </a:r>
            <a:r>
              <a:rPr lang="en-US" sz="800" dirty="0" smtClean="0">
                <a:latin typeface="Helvetica"/>
                <a:ea typeface="Calibri" charset="0"/>
                <a:cs typeface="Helvetica"/>
              </a:rPr>
              <a:t>GGGGACAAGTTTGTACAAAAAAGCAGGCTTACTCCTCTCAACTTTCAA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</a:p>
          <a:p>
            <a:pPr>
              <a:lnSpc>
                <a:spcPct val="150000"/>
              </a:lnSpc>
            </a:pPr>
            <a:r>
              <a:rPr lang="en-US" sz="800" dirty="0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>
                <a:latin typeface="Helvetica"/>
                <a:ea typeface="Calibri" charset="0"/>
                <a:cs typeface="Helvetica"/>
              </a:rPr>
              <a:t>Att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B2	</a:t>
            </a:r>
            <a:r>
              <a:rPr lang="en-US" sz="800" dirty="0" smtClean="0">
                <a:latin typeface="Helvetica"/>
                <a:ea typeface="Calibri" charset="0"/>
                <a:cs typeface="Helvetica"/>
              </a:rPr>
              <a:t>GGGGACCACTTTGTACAAGAAAGCTGGGTAGTGTAAGATGGGGTCTAA</a:t>
            </a:r>
            <a:r>
              <a:rPr lang="de-DE" sz="800" dirty="0" smtClean="0">
                <a:latin typeface="Helvetica"/>
                <a:ea typeface="Calibri" charset="0"/>
                <a:cs typeface="Helvetica"/>
              </a:rPr>
              <a:t>	</a:t>
            </a:r>
            <a:r>
              <a:rPr lang="en-US" sz="800" dirty="0" smtClean="0">
                <a:latin typeface="Helvetica"/>
                <a:ea typeface="Calibri" charset="0"/>
                <a:cs typeface="Helvetica"/>
              </a:rPr>
              <a:t>R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 smtClean="0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 smtClean="0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 err="1" smtClean="0">
                <a:latin typeface="Helvetica"/>
                <a:ea typeface="Calibri" charset="0"/>
                <a:cs typeface="Helvetica"/>
              </a:rPr>
              <a:t>Hind</a:t>
            </a:r>
            <a:r>
              <a:rPr lang="en-US" sz="800" dirty="0" err="1" smtClean="0">
                <a:latin typeface="Helvetica"/>
                <a:ea typeface="Calibri" charset="0"/>
                <a:cs typeface="Helvetica"/>
              </a:rPr>
              <a:t>II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TAAGCTTTACTCCTCTCAACTTTCAA	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GLDPA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BamH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TGGATCCGTGTAAGATGGGGTCTAA		R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RbcS.TP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BamH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AGGATCCATGGCTTCCTCTATGCTC	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RbcS.TP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EcoR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AGAATTCTTCGGAATCGGTAAGGTC		R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sGFP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EcoR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TGAATTCATGGTGAGCAAGGGCGAG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sGFP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Sac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</a:t>
            </a:r>
            <a:r>
              <a:rPr lang="en-US" sz="800" dirty="0">
                <a:solidFill>
                  <a:srgbClr val="000000"/>
                </a:solidFill>
                <a:latin typeface="Helvetica"/>
                <a:ea typeface="Times New Roman" charset="0"/>
                <a:cs typeface="Helvetica"/>
              </a:rPr>
              <a:t>ATGAGCTCTTACTTGTACAGCTCGTC		R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GLDT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Pvu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CGATCGTCGACCCGTAAATAGGTCAA		F</a:t>
            </a:r>
            <a:endParaRPr lang="de-DE" sz="800" dirty="0">
              <a:latin typeface="Helvetica"/>
              <a:ea typeface="Calibri" charset="0"/>
              <a:cs typeface="Helvetica"/>
            </a:endParaRPr>
          </a:p>
          <a:p>
            <a:pPr>
              <a:lnSpc>
                <a:spcPct val="150000"/>
              </a:lnSpc>
            </a:pPr>
            <a:r>
              <a:rPr lang="en-US" sz="800" dirty="0" err="1">
                <a:latin typeface="Helvetica"/>
                <a:ea typeface="Calibri" charset="0"/>
                <a:cs typeface="Helvetica"/>
              </a:rPr>
              <a:t>p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GLDT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-Ft+</a:t>
            </a:r>
            <a:r>
              <a:rPr lang="en-US" sz="800" i="1" dirty="0" err="1">
                <a:latin typeface="Helvetica"/>
                <a:ea typeface="Calibri" charset="0"/>
                <a:cs typeface="Helvetica"/>
              </a:rPr>
              <a:t>Asc</a:t>
            </a:r>
            <a:r>
              <a:rPr lang="en-US" sz="800" dirty="0" err="1">
                <a:latin typeface="Helvetica"/>
                <a:ea typeface="Calibri" charset="0"/>
                <a:cs typeface="Helvetica"/>
              </a:rPr>
              <a:t>I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		GGCGCGCCGTGTGCTTTATTCTTTAGAAAC</a:t>
            </a:r>
            <a:r>
              <a:rPr lang="en-US" sz="1000" dirty="0">
                <a:latin typeface="Helvetica"/>
                <a:ea typeface="Calibri" charset="0"/>
                <a:cs typeface="Helvetica"/>
              </a:rPr>
              <a:t>	</a:t>
            </a:r>
            <a:r>
              <a:rPr lang="en-US" sz="800" dirty="0">
                <a:latin typeface="Helvetica"/>
                <a:ea typeface="Calibri" charset="0"/>
                <a:cs typeface="Helvetica"/>
              </a:rPr>
              <a:t>R</a:t>
            </a:r>
            <a:endParaRPr lang="de-DE" sz="800" dirty="0">
              <a:effectLst/>
              <a:latin typeface="Helvetica"/>
              <a:ea typeface="Calibri" charset="0"/>
              <a:cs typeface="Helvetica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41741" y="134452"/>
            <a:ext cx="57956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charset="0"/>
                <a:ea typeface="Times New Roman" charset="0"/>
                <a:cs typeface="Times New Roman" charset="0"/>
              </a:rPr>
              <a:t>Table S2</a:t>
            </a:r>
            <a:r>
              <a:rPr lang="en-US" sz="800" b="1" dirty="0">
                <a:latin typeface="Times New Roman" charset="0"/>
                <a:ea typeface="Times New Roman" charset="0"/>
                <a:cs typeface="Times New Roman" charset="0"/>
              </a:rPr>
              <a:t>. Oligonucleotides used in this study</a:t>
            </a:r>
            <a:endParaRPr lang="en-US" sz="8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4871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Design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4</TotalTime>
  <Words>115</Words>
  <Application>Microsoft Macintosh PowerPoint</Application>
  <PresentationFormat>Custom</PresentationFormat>
  <Paragraphs>7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-Desig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Anwender</dc:creator>
  <cp:lastModifiedBy>Kumari Billakurthi</cp:lastModifiedBy>
  <cp:revision>75</cp:revision>
  <dcterms:created xsi:type="dcterms:W3CDTF">2017-10-12T12:14:20Z</dcterms:created>
  <dcterms:modified xsi:type="dcterms:W3CDTF">2018-11-12T11:26:57Z</dcterms:modified>
</cp:coreProperties>
</file>